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avi" ContentType="video/x-msvideo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3" r:id="rId2"/>
    <p:sldId id="262" r:id="rId3"/>
    <p:sldId id="266" r:id="rId4"/>
    <p:sldId id="257" r:id="rId5"/>
    <p:sldId id="256" r:id="rId6"/>
    <p:sldId id="259" r:id="rId7"/>
    <p:sldId id="258" r:id="rId8"/>
    <p:sldId id="264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67" d="100"/>
          <a:sy n="67" d="100"/>
        </p:scale>
        <p:origin x="5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B96B23-1C71-4F1A-8C83-4D9CB14B84AA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45E227-7259-499C-BB30-B131F075F4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6519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B6C122-132F-460C-9C73-3D34DFCB41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108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581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50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8944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216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72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739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057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085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7973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210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89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71BB3-A470-4539-B8BF-AA2DDCA86057}" type="datetimeFigureOut">
              <a:rPr lang="en-US" smtClean="0"/>
              <a:t>5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4FB5F-9BE4-47E0-9884-956FC4798C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802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3" Type="http://schemas.openxmlformats.org/officeDocument/2006/relationships/image" Target="../media/image9.png"/><Relationship Id="rId7" Type="http://schemas.openxmlformats.org/officeDocument/2006/relationships/image" Target="../media/image13.jpeg"/><Relationship Id="rId12" Type="http://schemas.openxmlformats.org/officeDocument/2006/relationships/image" Target="../media/image18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11" Type="http://schemas.openxmlformats.org/officeDocument/2006/relationships/image" Target="../media/image17.emf"/><Relationship Id="rId5" Type="http://schemas.openxmlformats.org/officeDocument/2006/relationships/image" Target="../media/image11.png"/><Relationship Id="rId10" Type="http://schemas.openxmlformats.org/officeDocument/2006/relationships/image" Target="../media/image16.emf"/><Relationship Id="rId4" Type="http://schemas.openxmlformats.org/officeDocument/2006/relationships/image" Target="../media/image10.png"/><Relationship Id="rId9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25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media" Target="../media/media3.mp4"/><Relationship Id="rId7" Type="http://schemas.openxmlformats.org/officeDocument/2006/relationships/image" Target="../media/image27.png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6" Type="http://schemas.openxmlformats.org/officeDocument/2006/relationships/image" Target="../media/image26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3.mp4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649325" y="975787"/>
            <a:ext cx="7258154" cy="2457063"/>
            <a:chOff x="412672" y="2398833"/>
            <a:chExt cx="7258154" cy="2457063"/>
          </a:xfrm>
        </p:grpSpPr>
        <p:grpSp>
          <p:nvGrpSpPr>
            <p:cNvPr id="8" name="Group 7"/>
            <p:cNvGrpSpPr/>
            <p:nvPr/>
          </p:nvGrpSpPr>
          <p:grpSpPr>
            <a:xfrm>
              <a:off x="412672" y="2754864"/>
              <a:ext cx="7145406" cy="2101032"/>
              <a:chOff x="241283" y="1992863"/>
              <a:chExt cx="11063929" cy="3253232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747826" y="1992863"/>
                <a:ext cx="10557386" cy="2573662"/>
                <a:chOff x="747826" y="1992863"/>
                <a:chExt cx="10557386" cy="2573662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6763" r="-2128" b="33675"/>
                <a:stretch/>
              </p:blipFill>
              <p:spPr>
                <a:xfrm>
                  <a:off x="747826" y="1992863"/>
                  <a:ext cx="2560320" cy="2573662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6472" r="-1835" b="33675"/>
                <a:stretch/>
              </p:blipFill>
              <p:spPr>
                <a:xfrm>
                  <a:off x="3390140" y="1992863"/>
                  <a:ext cx="2560321" cy="2573662"/>
                </a:xfrm>
                <a:prstGeom prst="rect">
                  <a:avLst/>
                </a:prstGeom>
              </p:spPr>
            </p:pic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6257" r="-2334" b="33142"/>
                <a:stretch/>
              </p:blipFill>
              <p:spPr>
                <a:xfrm>
                  <a:off x="8744035" y="1992863"/>
                  <a:ext cx="2561177" cy="2573662"/>
                </a:xfrm>
                <a:prstGeom prst="rect">
                  <a:avLst/>
                </a:prstGeom>
              </p:spPr>
            </p:pic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6801" r="-2886" b="33132"/>
                <a:stretch/>
              </p:blipFill>
              <p:spPr>
                <a:xfrm>
                  <a:off x="6101039" y="1992863"/>
                  <a:ext cx="2561002" cy="2573662"/>
                </a:xfrm>
                <a:prstGeom prst="rect">
                  <a:avLst/>
                </a:prstGeom>
              </p:spPr>
            </p:pic>
          </p:grpSp>
          <p:grpSp>
            <p:nvGrpSpPr>
              <p:cNvPr id="19" name="Group 18"/>
              <p:cNvGrpSpPr/>
              <p:nvPr/>
            </p:nvGrpSpPr>
            <p:grpSpPr>
              <a:xfrm>
                <a:off x="241283" y="2305913"/>
                <a:ext cx="5016020" cy="2940182"/>
                <a:chOff x="241283" y="2305913"/>
                <a:chExt cx="5016020" cy="2940182"/>
              </a:xfrm>
            </p:grpSpPr>
            <p:cxnSp>
              <p:nvCxnSpPr>
                <p:cNvPr id="12" name="Straight Arrow Connector 11"/>
                <p:cNvCxnSpPr/>
                <p:nvPr/>
              </p:nvCxnSpPr>
              <p:spPr>
                <a:xfrm flipH="1" flipV="1">
                  <a:off x="484632" y="3136392"/>
                  <a:ext cx="9144" cy="1883664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Arrow Connector 13"/>
                <p:cNvCxnSpPr/>
                <p:nvPr/>
              </p:nvCxnSpPr>
              <p:spPr>
                <a:xfrm>
                  <a:off x="484632" y="5020056"/>
                  <a:ext cx="3557016" cy="0"/>
                </a:xfrm>
                <a:prstGeom prst="straightConnector1">
                  <a:avLst/>
                </a:prstGeom>
                <a:ln w="1905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6"/>
                <p:cNvSpPr txBox="1"/>
                <p:nvPr/>
              </p:nvSpPr>
              <p:spPr>
                <a:xfrm>
                  <a:off x="4043067" y="4769534"/>
                  <a:ext cx="1214236" cy="4765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MV-GFP</a:t>
                  </a: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6200000">
                  <a:off x="35022" y="2512174"/>
                  <a:ext cx="889083" cy="47656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CD86</a:t>
                  </a:r>
                </a:p>
              </p:txBody>
            </p:sp>
          </p:grpSp>
        </p:grpSp>
        <p:grpSp>
          <p:nvGrpSpPr>
            <p:cNvPr id="2" name="Group 1"/>
            <p:cNvGrpSpPr/>
            <p:nvPr/>
          </p:nvGrpSpPr>
          <p:grpSpPr>
            <a:xfrm>
              <a:off x="920997" y="2398833"/>
              <a:ext cx="6749829" cy="307777"/>
              <a:chOff x="882897" y="1494267"/>
              <a:chExt cx="6749829" cy="307777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882897" y="1494267"/>
                <a:ext cx="12394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V DCs &lt; 50%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635183" y="1494267"/>
                <a:ext cx="123944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V DCs &gt; 50%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532145" y="1494267"/>
                <a:ext cx="9076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ock DCs</a:t>
                </a:r>
                <a:endParaRPr lang="en-US" sz="14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865896" y="1494267"/>
                <a:ext cx="17668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V DCs – Isotype Ctrl</a:t>
                </a:r>
                <a:endParaRPr lang="en-US" sz="1400" b="1" dirty="0"/>
              </a:p>
            </p:txBody>
          </p:sp>
        </p:grpSp>
      </p:grpSp>
      <p:sp>
        <p:nvSpPr>
          <p:cNvPr id="24" name="TextBox 23"/>
          <p:cNvSpPr txBox="1"/>
          <p:nvPr/>
        </p:nvSpPr>
        <p:spPr>
          <a:xfrm>
            <a:off x="498778" y="3755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1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649325" y="3553637"/>
            <a:ext cx="5659235" cy="2453447"/>
            <a:chOff x="470102" y="1546912"/>
            <a:chExt cx="7401741" cy="3230185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7"/>
            <a:srcRect l="18827" t="1" r="-1468" b="32854"/>
            <a:stretch/>
          </p:blipFill>
          <p:spPr>
            <a:xfrm>
              <a:off x="3310128" y="1923037"/>
              <a:ext cx="2254272" cy="2274059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8"/>
            <a:srcRect l="19208" r="-1216" b="34524"/>
            <a:stretch/>
          </p:blipFill>
          <p:spPr>
            <a:xfrm>
              <a:off x="5664984" y="1923036"/>
              <a:ext cx="2206859" cy="2274059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9"/>
            <a:srcRect l="18509" b="31911"/>
            <a:stretch/>
          </p:blipFill>
          <p:spPr>
            <a:xfrm>
              <a:off x="1025702" y="1923037"/>
              <a:ext cx="2183842" cy="2333399"/>
            </a:xfrm>
            <a:prstGeom prst="rect">
              <a:avLst/>
            </a:prstGeom>
          </p:spPr>
        </p:pic>
        <p:grpSp>
          <p:nvGrpSpPr>
            <p:cNvPr id="29" name="Group 28"/>
            <p:cNvGrpSpPr/>
            <p:nvPr/>
          </p:nvGrpSpPr>
          <p:grpSpPr>
            <a:xfrm>
              <a:off x="470102" y="2209046"/>
              <a:ext cx="3900970" cy="2568051"/>
              <a:chOff x="214809" y="1875809"/>
              <a:chExt cx="5185333" cy="3413561"/>
            </a:xfrm>
          </p:grpSpPr>
          <p:cxnSp>
            <p:nvCxnSpPr>
              <p:cNvPr id="33" name="Straight Arrow Connector 32"/>
              <p:cNvCxnSpPr/>
              <p:nvPr/>
            </p:nvCxnSpPr>
            <p:spPr>
              <a:xfrm flipH="1" flipV="1">
                <a:off x="484632" y="3136392"/>
                <a:ext cx="9144" cy="1883664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/>
              <p:cNvCxnSpPr/>
              <p:nvPr/>
            </p:nvCxnSpPr>
            <p:spPr>
              <a:xfrm>
                <a:off x="484632" y="5020056"/>
                <a:ext cx="3557016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4036812" y="4750739"/>
                <a:ext cx="1363330" cy="5386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MV-GFP</a:t>
                </a: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 rot="16200000">
                <a:off x="-164569" y="2255187"/>
                <a:ext cx="1293834" cy="5350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HLA-DR</a:t>
                </a: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3426766" y="1546912"/>
              <a:ext cx="2000553" cy="4052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V DCs – Donor A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789265" y="1546912"/>
              <a:ext cx="1992167" cy="4052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V DCs – Donor B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510878" y="1580615"/>
              <a:ext cx="1033334" cy="352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Mock DCs</a:t>
              </a:r>
              <a:endParaRPr lang="en-US" sz="1400" b="1" dirty="0"/>
            </a:p>
          </p:txBody>
        </p:sp>
      </p:grpSp>
      <p:sp>
        <p:nvSpPr>
          <p:cNvPr id="37" name="Rectangle 36"/>
          <p:cNvSpPr/>
          <p:nvPr/>
        </p:nvSpPr>
        <p:spPr>
          <a:xfrm>
            <a:off x="725686" y="6139840"/>
            <a:ext cx="111061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ig.1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enotypic characterization of DCs before and after MV infection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ouble detection of MV and maturation markers, CD86 (top panel) and HLA-DR (bottom panel)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68527" y="8038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7475480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8978">
            <a:extLst>
              <a:ext uri="{FF2B5EF4-FFF2-40B4-BE49-F238E27FC236}">
                <a16:creationId xmlns:a16="http://schemas.microsoft.com/office/drawing/2014/main" xmlns="" id="{D86E0147-03E0-204E-A809-CF106E002DD8}"/>
              </a:ext>
            </a:extLst>
          </p:cNvPr>
          <p:cNvGrpSpPr>
            <a:grpSpLocks/>
          </p:cNvGrpSpPr>
          <p:nvPr/>
        </p:nvGrpSpPr>
        <p:grpSpPr bwMode="auto">
          <a:xfrm>
            <a:off x="607844" y="1065335"/>
            <a:ext cx="6108835" cy="2073877"/>
            <a:chOff x="900987" y="1360079"/>
            <a:chExt cx="3670613" cy="1247055"/>
          </a:xfrm>
        </p:grpSpPr>
        <p:grpSp>
          <p:nvGrpSpPr>
            <p:cNvPr id="5" name="Gruppieren 28">
              <a:extLst>
                <a:ext uri="{FF2B5EF4-FFF2-40B4-BE49-F238E27FC236}">
                  <a16:creationId xmlns:a16="http://schemas.microsoft.com/office/drawing/2014/main" xmlns="" id="{4C9827BC-549F-F14D-99C7-A2F4302ABC7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971600" y="1484784"/>
              <a:ext cx="3600000" cy="1080000"/>
              <a:chOff x="971600" y="1484784"/>
              <a:chExt cx="4233758" cy="1290320"/>
            </a:xfrm>
          </p:grpSpPr>
          <p:pic>
            <p:nvPicPr>
              <p:cNvPr id="18" name="Picture 4">
                <a:extLst>
                  <a:ext uri="{FF2B5EF4-FFF2-40B4-BE49-F238E27FC236}">
                    <a16:creationId xmlns:a16="http://schemas.microsoft.com/office/drawing/2014/main" xmlns="" id="{92E9AA9E-52A4-FD43-B0A9-A951E2CCEA7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923928" y="1484784"/>
                <a:ext cx="1281430" cy="12884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9" name="Picture 6">
                <a:extLst>
                  <a:ext uri="{FF2B5EF4-FFF2-40B4-BE49-F238E27FC236}">
                    <a16:creationId xmlns:a16="http://schemas.microsoft.com/office/drawing/2014/main" xmlns="" id="{0BCB9200-6047-F54E-8A8B-70B0BC8A113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50215" y="1484784"/>
                <a:ext cx="1261745" cy="12884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" name="Picture 5">
                <a:extLst>
                  <a:ext uri="{FF2B5EF4-FFF2-40B4-BE49-F238E27FC236}">
                    <a16:creationId xmlns:a16="http://schemas.microsoft.com/office/drawing/2014/main" xmlns="" id="{17FA9A41-60EB-324E-B78F-89A1FE1828C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87815" y="1486688"/>
                <a:ext cx="1241425" cy="12884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1" name="Picture 3">
                <a:extLst>
                  <a:ext uri="{FF2B5EF4-FFF2-40B4-BE49-F238E27FC236}">
                    <a16:creationId xmlns:a16="http://schemas.microsoft.com/office/drawing/2014/main" xmlns="" id="{F35F7A01-323B-4C4B-9DA8-59A6D5D93AE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71600" y="1486689"/>
                <a:ext cx="1295400" cy="128841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" name="Textfeld 29">
              <a:extLst>
                <a:ext uri="{FF2B5EF4-FFF2-40B4-BE49-F238E27FC236}">
                  <a16:creationId xmlns:a16="http://schemas.microsoft.com/office/drawing/2014/main" xmlns="" id="{32CC0EE8-9F35-9F42-8761-6CB95DF500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6282" y="1363172"/>
              <a:ext cx="264109" cy="166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Arial" panose="020B0604020202020204" pitchFamily="34" charset="0"/>
                </a:rPr>
                <a:t>iDC</a:t>
              </a:r>
            </a:p>
          </p:txBody>
        </p:sp>
        <p:sp>
          <p:nvSpPr>
            <p:cNvPr id="7" name="Textfeld 30">
              <a:extLst>
                <a:ext uri="{FF2B5EF4-FFF2-40B4-BE49-F238E27FC236}">
                  <a16:creationId xmlns:a16="http://schemas.microsoft.com/office/drawing/2014/main" xmlns="" id="{EF1558F4-6C27-5A41-9ED4-CB73FF583A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62728" y="1360957"/>
              <a:ext cx="612693" cy="166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Arial" panose="020B0604020202020204" pitchFamily="34" charset="0"/>
                </a:rPr>
                <a:t>iDC + mock</a:t>
              </a:r>
            </a:p>
          </p:txBody>
        </p:sp>
        <p:sp>
          <p:nvSpPr>
            <p:cNvPr id="8" name="Textfeld 31">
              <a:extLst>
                <a:ext uri="{FF2B5EF4-FFF2-40B4-BE49-F238E27FC236}">
                  <a16:creationId xmlns:a16="http://schemas.microsoft.com/office/drawing/2014/main" xmlns="" id="{702179CB-0A2D-E441-A1C1-EB7D3E2AA7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19263" y="1360079"/>
              <a:ext cx="492493" cy="166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Arial" panose="020B0604020202020204" pitchFamily="34" charset="0"/>
                </a:rPr>
                <a:t>iDC +MV</a:t>
              </a:r>
            </a:p>
          </p:txBody>
        </p:sp>
        <p:sp>
          <p:nvSpPr>
            <p:cNvPr id="9" name="Textfeld 32">
              <a:extLst>
                <a:ext uri="{FF2B5EF4-FFF2-40B4-BE49-F238E27FC236}">
                  <a16:creationId xmlns:a16="http://schemas.microsoft.com/office/drawing/2014/main" xmlns="" id="{D8885633-8B27-5C4C-A50D-C7C6ED58DE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77589" y="1360079"/>
              <a:ext cx="320937" cy="1665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Arial" panose="020B0604020202020204" pitchFamily="34" charset="0"/>
                </a:rPr>
                <a:t>mDC</a:t>
              </a:r>
            </a:p>
          </p:txBody>
        </p:sp>
        <p:sp>
          <p:nvSpPr>
            <p:cNvPr id="10" name="Textfeld 33">
              <a:extLst>
                <a:ext uri="{FF2B5EF4-FFF2-40B4-BE49-F238E27FC236}">
                  <a16:creationId xmlns:a16="http://schemas.microsoft.com/office/drawing/2014/main" xmlns="" id="{9E145035-F2F2-6049-9C3D-2C1286EFF2D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92232" y="1605549"/>
              <a:ext cx="371023" cy="1480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MFI:5.4</a:t>
              </a:r>
            </a:p>
          </p:txBody>
        </p:sp>
        <p:sp>
          <p:nvSpPr>
            <p:cNvPr id="11" name="Textfeld 40">
              <a:extLst>
                <a:ext uri="{FF2B5EF4-FFF2-40B4-BE49-F238E27FC236}">
                  <a16:creationId xmlns:a16="http://schemas.microsoft.com/office/drawing/2014/main" xmlns="" id="{B3EDC1FC-2BC0-5849-8BCD-F74227A8E1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0908" y="1606330"/>
              <a:ext cx="371023" cy="1480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MFI:6.6</a:t>
              </a:r>
            </a:p>
          </p:txBody>
        </p:sp>
        <p:sp>
          <p:nvSpPr>
            <p:cNvPr id="12" name="Textfeld 41">
              <a:extLst>
                <a:ext uri="{FF2B5EF4-FFF2-40B4-BE49-F238E27FC236}">
                  <a16:creationId xmlns:a16="http://schemas.microsoft.com/office/drawing/2014/main" xmlns="" id="{CAFBC1E3-BBF8-834B-A55E-3F96B59C1E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53833" y="1606330"/>
              <a:ext cx="413404" cy="1480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MFI:22.6</a:t>
              </a:r>
            </a:p>
          </p:txBody>
        </p:sp>
        <p:sp>
          <p:nvSpPr>
            <p:cNvPr id="13" name="Textfeld 42">
              <a:extLst>
                <a:ext uri="{FF2B5EF4-FFF2-40B4-BE49-F238E27FC236}">
                  <a16:creationId xmlns:a16="http://schemas.microsoft.com/office/drawing/2014/main" xmlns="" id="{AFF113E6-B4A5-1444-BC83-D3016020D8A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88960" y="1606330"/>
              <a:ext cx="413404" cy="1480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MFI:28.3</a:t>
              </a:r>
            </a:p>
          </p:txBody>
        </p:sp>
        <p:cxnSp>
          <p:nvCxnSpPr>
            <p:cNvPr id="14" name="Gerade Verbindung mit Pfeil 44">
              <a:extLst>
                <a:ext uri="{FF2B5EF4-FFF2-40B4-BE49-F238E27FC236}">
                  <a16:creationId xmlns:a16="http://schemas.microsoft.com/office/drawing/2014/main" xmlns="" id="{5EAD7D05-8137-5F46-A5BD-9325163B60DC}"/>
                </a:ext>
              </a:extLst>
            </p:cNvPr>
            <p:cNvCxnSpPr/>
            <p:nvPr/>
          </p:nvCxnSpPr>
          <p:spPr>
            <a:xfrm flipV="1">
              <a:off x="1281637" y="2527252"/>
              <a:ext cx="1694408" cy="118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mit Pfeil 48">
              <a:extLst>
                <a:ext uri="{FF2B5EF4-FFF2-40B4-BE49-F238E27FC236}">
                  <a16:creationId xmlns:a16="http://schemas.microsoft.com/office/drawing/2014/main" xmlns="" id="{3CF4A1C0-F3BA-2C47-BE4B-6F7D7CB2A998}"/>
                </a:ext>
              </a:extLst>
            </p:cNvPr>
            <p:cNvCxnSpPr/>
            <p:nvPr/>
          </p:nvCxnSpPr>
          <p:spPr>
            <a:xfrm flipV="1">
              <a:off x="1044086" y="1606330"/>
              <a:ext cx="0" cy="67044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49">
              <a:extLst>
                <a:ext uri="{FF2B5EF4-FFF2-40B4-BE49-F238E27FC236}">
                  <a16:creationId xmlns:a16="http://schemas.microsoft.com/office/drawing/2014/main" xmlns="" id="{6BE43847-6EC3-7D4E-960E-A7F6379018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9235" y="2447369"/>
              <a:ext cx="400715" cy="1597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CD86</a:t>
              </a:r>
            </a:p>
          </p:txBody>
        </p:sp>
        <p:sp>
          <p:nvSpPr>
            <p:cNvPr id="17" name="Textfeld 50">
              <a:extLst>
                <a:ext uri="{FF2B5EF4-FFF2-40B4-BE49-F238E27FC236}">
                  <a16:creationId xmlns:a16="http://schemas.microsoft.com/office/drawing/2014/main" xmlns="" id="{1E10B4D9-C4F9-3742-8C43-C0DB46257A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65666" y="1753923"/>
              <a:ext cx="71686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>
                  <a:latin typeface="Arial" panose="020B0604020202020204" pitchFamily="34" charset="0"/>
                </a:rPr>
                <a:t>% of max</a:t>
              </a:r>
            </a:p>
          </p:txBody>
        </p:sp>
      </p:grpSp>
      <p:grpSp>
        <p:nvGrpSpPr>
          <p:cNvPr id="24" name="Gruppieren 38977">
            <a:extLst>
              <a:ext uri="{FF2B5EF4-FFF2-40B4-BE49-F238E27FC236}">
                <a16:creationId xmlns:a16="http://schemas.microsoft.com/office/drawing/2014/main" xmlns="" id="{3EF3FCD4-9234-8B43-82F2-B99B422E22C4}"/>
              </a:ext>
            </a:extLst>
          </p:cNvPr>
          <p:cNvGrpSpPr>
            <a:grpSpLocks/>
          </p:cNvGrpSpPr>
          <p:nvPr/>
        </p:nvGrpSpPr>
        <p:grpSpPr bwMode="auto">
          <a:xfrm>
            <a:off x="7161762" y="1083181"/>
            <a:ext cx="4384043" cy="2172489"/>
            <a:chOff x="973192" y="3135101"/>
            <a:chExt cx="3677934" cy="1823921"/>
          </a:xfrm>
        </p:grpSpPr>
        <p:pic>
          <p:nvPicPr>
            <p:cNvPr id="25" name="Grafik 34">
              <a:extLst>
                <a:ext uri="{FF2B5EF4-FFF2-40B4-BE49-F238E27FC236}">
                  <a16:creationId xmlns:a16="http://schemas.microsoft.com/office/drawing/2014/main" xmlns="" id="{187105D6-7B6E-AE47-A67F-0BB3AFC3D54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15616" y="3140969"/>
              <a:ext cx="1774800" cy="14413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6" name="Grafik 35">
              <a:extLst>
                <a:ext uri="{FF2B5EF4-FFF2-40B4-BE49-F238E27FC236}">
                  <a16:creationId xmlns:a16="http://schemas.microsoft.com/office/drawing/2014/main" xmlns="" id="{99F8D7BE-7605-7B45-8C4B-ECE83DCF296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77935" y="3135101"/>
              <a:ext cx="1773191" cy="144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Textfeld 51">
              <a:extLst>
                <a:ext uri="{FF2B5EF4-FFF2-40B4-BE49-F238E27FC236}">
                  <a16:creationId xmlns:a16="http://schemas.microsoft.com/office/drawing/2014/main" xmlns="" id="{1CC1538A-8400-B343-8493-DC2530169B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80535" y="3745429"/>
              <a:ext cx="1017699" cy="232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200" dirty="0">
                  <a:latin typeface="Arial" panose="020B0604020202020204" pitchFamily="34" charset="0"/>
                </a:rPr>
                <a:t>CD86+ DC (%)</a:t>
              </a:r>
            </a:p>
          </p:txBody>
        </p:sp>
        <p:sp>
          <p:nvSpPr>
            <p:cNvPr id="28" name="Textfeld 59">
              <a:extLst>
                <a:ext uri="{FF2B5EF4-FFF2-40B4-BE49-F238E27FC236}">
                  <a16:creationId xmlns:a16="http://schemas.microsoft.com/office/drawing/2014/main" xmlns="" id="{42C32A49-EADB-ED4D-B529-725BB7B525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3688" y="4712626"/>
              <a:ext cx="399470" cy="2463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iDC</a:t>
              </a:r>
            </a:p>
          </p:txBody>
        </p:sp>
        <p:sp>
          <p:nvSpPr>
            <p:cNvPr id="29" name="Textfeld 62">
              <a:extLst>
                <a:ext uri="{FF2B5EF4-FFF2-40B4-BE49-F238E27FC236}">
                  <a16:creationId xmlns:a16="http://schemas.microsoft.com/office/drawing/2014/main" xmlns="" id="{C5AF4E9B-3003-8545-8008-31CDDEBE29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8544" y="4478923"/>
              <a:ext cx="478018" cy="2463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>
                  <a:latin typeface="Arial" panose="020B0604020202020204" pitchFamily="34" charset="0"/>
                </a:rPr>
                <a:t>mDC</a:t>
              </a:r>
            </a:p>
          </p:txBody>
        </p:sp>
        <p:sp>
          <p:nvSpPr>
            <p:cNvPr id="30" name="Textfeld 64">
              <a:extLst>
                <a:ext uri="{FF2B5EF4-FFF2-40B4-BE49-F238E27FC236}">
                  <a16:creationId xmlns:a16="http://schemas.microsoft.com/office/drawing/2014/main" xmlns="" id="{2F59A77E-BA9A-BE44-9353-87308B73A3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91680" y="4478923"/>
              <a:ext cx="49084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>
                  <a:latin typeface="Arial" panose="020B0604020202020204" pitchFamily="34" charset="0"/>
                </a:rPr>
                <a:t>mock</a:t>
              </a:r>
            </a:p>
          </p:txBody>
        </p:sp>
        <p:sp>
          <p:nvSpPr>
            <p:cNvPr id="31" name="Textfeld 65">
              <a:extLst>
                <a:ext uri="{FF2B5EF4-FFF2-40B4-BE49-F238E27FC236}">
                  <a16:creationId xmlns:a16="http://schemas.microsoft.com/office/drawing/2014/main" xmlns="" id="{AE9286A2-6737-E244-9CC5-4DB15C7B5D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22131" y="4478923"/>
              <a:ext cx="37702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>
                  <a:latin typeface="Arial" panose="020B0604020202020204" pitchFamily="34" charset="0"/>
                </a:rPr>
                <a:t>MV</a:t>
              </a:r>
            </a:p>
          </p:txBody>
        </p:sp>
        <p:sp>
          <p:nvSpPr>
            <p:cNvPr id="32" name="Textfeld 53">
              <a:extLst>
                <a:ext uri="{FF2B5EF4-FFF2-40B4-BE49-F238E27FC236}">
                  <a16:creationId xmlns:a16="http://schemas.microsoft.com/office/drawing/2014/main" xmlns="" id="{3412E0B8-FD66-7041-B462-E9214306C3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75656" y="4293096"/>
              <a:ext cx="316112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100">
                  <a:latin typeface="Arial" panose="020B0604020202020204" pitchFamily="34" charset="0"/>
                </a:rPr>
                <a:t>-</a:t>
              </a:r>
              <a:r>
                <a:rPr lang="de-DE" altLang="de-DE" sz="2400">
                  <a:latin typeface="Arial" panose="020B0604020202020204" pitchFamily="34" charset="0"/>
                </a:rPr>
                <a:t> </a:t>
              </a:r>
            </a:p>
          </p:txBody>
        </p:sp>
        <p:cxnSp>
          <p:nvCxnSpPr>
            <p:cNvPr id="33" name="Gerade Verbindung 55">
              <a:extLst>
                <a:ext uri="{FF2B5EF4-FFF2-40B4-BE49-F238E27FC236}">
                  <a16:creationId xmlns:a16="http://schemas.microsoft.com/office/drawing/2014/main" xmlns="" id="{F0BF9BDD-5361-274B-8E4D-916EF717E806}"/>
                </a:ext>
              </a:extLst>
            </p:cNvPr>
            <p:cNvCxnSpPr/>
            <p:nvPr/>
          </p:nvCxnSpPr>
          <p:spPr>
            <a:xfrm>
              <a:off x="1404456" y="4725472"/>
              <a:ext cx="957331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" name="Gruppieren 56">
              <a:extLst>
                <a:ext uri="{FF2B5EF4-FFF2-40B4-BE49-F238E27FC236}">
                  <a16:creationId xmlns:a16="http://schemas.microsoft.com/office/drawing/2014/main" xmlns="" id="{A7A0CE87-9240-0A41-BA64-754DC5EBB72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220779" y="4293096"/>
              <a:ext cx="1400906" cy="665926"/>
              <a:chOff x="3131840" y="4293096"/>
              <a:chExt cx="1400906" cy="665926"/>
            </a:xfrm>
          </p:grpSpPr>
          <p:sp>
            <p:nvSpPr>
              <p:cNvPr id="38" name="Textfeld 70">
                <a:extLst>
                  <a:ext uri="{FF2B5EF4-FFF2-40B4-BE49-F238E27FC236}">
                    <a16:creationId xmlns:a16="http://schemas.microsoft.com/office/drawing/2014/main" xmlns="" id="{A605C965-7F23-2D41-9450-37384464DF2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19872" y="4712626"/>
                <a:ext cx="399470" cy="2463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DE" altLang="de-DE" sz="1000">
                    <a:latin typeface="Arial" panose="020B0604020202020204" pitchFamily="34" charset="0"/>
                  </a:rPr>
                  <a:t>iDC</a:t>
                </a:r>
              </a:p>
            </p:txBody>
          </p:sp>
          <p:sp>
            <p:nvSpPr>
              <p:cNvPr id="39" name="Textfeld 71">
                <a:extLst>
                  <a:ext uri="{FF2B5EF4-FFF2-40B4-BE49-F238E27FC236}">
                    <a16:creationId xmlns:a16="http://schemas.microsoft.com/office/drawing/2014/main" xmlns="" id="{95E027E0-BDED-4E45-B2BF-6653119C5BB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54728" y="4478923"/>
                <a:ext cx="478018" cy="2463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DE" altLang="de-DE" sz="1000">
                    <a:latin typeface="Arial" panose="020B0604020202020204" pitchFamily="34" charset="0"/>
                  </a:rPr>
                  <a:t>mDC</a:t>
                </a:r>
              </a:p>
            </p:txBody>
          </p:sp>
          <p:sp>
            <p:nvSpPr>
              <p:cNvPr id="40" name="Textfeld 72">
                <a:extLst>
                  <a:ext uri="{FF2B5EF4-FFF2-40B4-BE49-F238E27FC236}">
                    <a16:creationId xmlns:a16="http://schemas.microsoft.com/office/drawing/2014/main" xmlns="" id="{518E32A7-9BF8-5B45-BA0C-5C63EA0A50B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47864" y="4478923"/>
                <a:ext cx="49084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DE" altLang="de-DE" sz="1000">
                    <a:latin typeface="Arial" panose="020B0604020202020204" pitchFamily="34" charset="0"/>
                  </a:rPr>
                  <a:t>mock</a:t>
                </a:r>
              </a:p>
            </p:txBody>
          </p:sp>
          <p:sp>
            <p:nvSpPr>
              <p:cNvPr id="41" name="Textfeld 73">
                <a:extLst>
                  <a:ext uri="{FF2B5EF4-FFF2-40B4-BE49-F238E27FC236}">
                    <a16:creationId xmlns:a16="http://schemas.microsoft.com/office/drawing/2014/main" xmlns="" id="{92CBBE39-F7B7-714E-828D-B0B271531AF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778315" y="4478923"/>
                <a:ext cx="37702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DE" altLang="de-DE" sz="1000">
                    <a:latin typeface="Arial" panose="020B0604020202020204" pitchFamily="34" charset="0"/>
                  </a:rPr>
                  <a:t>MV</a:t>
                </a:r>
              </a:p>
            </p:txBody>
          </p:sp>
          <p:sp>
            <p:nvSpPr>
              <p:cNvPr id="42" name="Textfeld 74">
                <a:extLst>
                  <a:ext uri="{FF2B5EF4-FFF2-40B4-BE49-F238E27FC236}">
                    <a16:creationId xmlns:a16="http://schemas.microsoft.com/office/drawing/2014/main" xmlns="" id="{791CA8F1-B928-5946-A506-35E23ECF9D8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131840" y="4293096"/>
                <a:ext cx="316112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DE" altLang="de-DE" sz="1100">
                    <a:latin typeface="Arial" panose="020B0604020202020204" pitchFamily="34" charset="0"/>
                  </a:rPr>
                  <a:t>-</a:t>
                </a:r>
                <a:r>
                  <a:rPr lang="de-DE" altLang="de-DE" sz="2400">
                    <a:latin typeface="Arial" panose="020B0604020202020204" pitchFamily="34" charset="0"/>
                  </a:rPr>
                  <a:t> </a:t>
                </a:r>
              </a:p>
            </p:txBody>
          </p:sp>
        </p:grpSp>
        <p:cxnSp>
          <p:nvCxnSpPr>
            <p:cNvPr id="35" name="Gerade Verbindung 76">
              <a:extLst>
                <a:ext uri="{FF2B5EF4-FFF2-40B4-BE49-F238E27FC236}">
                  <a16:creationId xmlns:a16="http://schemas.microsoft.com/office/drawing/2014/main" xmlns="" id="{AEAF8DC9-6E83-8B40-8FA3-15B35CC821BF}"/>
                </a:ext>
              </a:extLst>
            </p:cNvPr>
            <p:cNvCxnSpPr/>
            <p:nvPr/>
          </p:nvCxnSpPr>
          <p:spPr>
            <a:xfrm>
              <a:off x="3180996" y="4725472"/>
              <a:ext cx="9589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feld 38975">
              <a:extLst>
                <a:ext uri="{FF2B5EF4-FFF2-40B4-BE49-F238E27FC236}">
                  <a16:creationId xmlns:a16="http://schemas.microsoft.com/office/drawing/2014/main" xmlns="" id="{26843112-A39A-474D-BEEB-14480BD892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93274" y="3300612"/>
              <a:ext cx="74251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&gt;50% MV</a:t>
              </a:r>
            </a:p>
          </p:txBody>
        </p:sp>
        <p:sp>
          <p:nvSpPr>
            <p:cNvPr id="37" name="Textfeld 38976">
              <a:extLst>
                <a:ext uri="{FF2B5EF4-FFF2-40B4-BE49-F238E27FC236}">
                  <a16:creationId xmlns:a16="http://schemas.microsoft.com/office/drawing/2014/main" xmlns="" id="{D940728D-1FAA-094F-93B8-4E96626F03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73960" y="3300612"/>
              <a:ext cx="74251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DE" altLang="de-DE" sz="1000" dirty="0">
                  <a:latin typeface="Arial" panose="020B0604020202020204" pitchFamily="34" charset="0"/>
                </a:rPr>
                <a:t>&lt;50% MV</a:t>
              </a:r>
            </a:p>
          </p:txBody>
        </p:sp>
      </p:grpSp>
      <p:sp>
        <p:nvSpPr>
          <p:cNvPr id="53" name="Rectangle 52"/>
          <p:cNvSpPr/>
          <p:nvPr/>
        </p:nvSpPr>
        <p:spPr>
          <a:xfrm>
            <a:off x="498778" y="6030669"/>
            <a:ext cx="1110615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ig.1) B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stogram representation of CD86 maturation marker (left panel) with the according CD86+ DC population compared to the isotype control. Results are expressed as mean ± SEM of at least 3 independent experiment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enotypic characterization of DCs before and after MV infection for HLA-DR (left graphs), DC-SIGN (middle graphs) and CD80 (right graphs) as MFI values. Each graph shows one independent donor in three replicates. </a:t>
            </a:r>
            <a:endParaRPr lang="en-US" sz="12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68527" y="8038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19776" y="3140823"/>
            <a:ext cx="3055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98778" y="3755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1</a:t>
            </a:r>
          </a:p>
        </p:txBody>
      </p:sp>
      <p:grpSp>
        <p:nvGrpSpPr>
          <p:cNvPr id="59" name="Group 58"/>
          <p:cNvGrpSpPr/>
          <p:nvPr/>
        </p:nvGrpSpPr>
        <p:grpSpPr>
          <a:xfrm>
            <a:off x="498778" y="3426232"/>
            <a:ext cx="11155128" cy="2772559"/>
            <a:chOff x="508754" y="3542493"/>
            <a:chExt cx="11155128" cy="2772559"/>
          </a:xfrm>
        </p:grpSpPr>
        <p:grpSp>
          <p:nvGrpSpPr>
            <p:cNvPr id="56" name="Group 55"/>
            <p:cNvGrpSpPr/>
            <p:nvPr/>
          </p:nvGrpSpPr>
          <p:grpSpPr>
            <a:xfrm>
              <a:off x="1641941" y="3542493"/>
              <a:ext cx="8575713" cy="279801"/>
              <a:chOff x="1979310" y="3631962"/>
              <a:chExt cx="8575713" cy="279801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1979310" y="3634764"/>
                <a:ext cx="77296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LA-DR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6056770" y="3634763"/>
                <a:ext cx="83388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C-SIGN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9979224" y="3631962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80</a:t>
                </a:r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8754" y="3788442"/>
              <a:ext cx="1736640" cy="2291859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83592" y="3785790"/>
              <a:ext cx="1736640" cy="2529262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519283" y="3792671"/>
              <a:ext cx="1738165" cy="2294902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089198" y="3772335"/>
              <a:ext cx="1779332" cy="2345122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210654" y="3758442"/>
              <a:ext cx="1828123" cy="2410560"/>
            </a:xfrm>
            <a:prstGeom prst="rect">
              <a:avLst/>
            </a:prstGeom>
          </p:spPr>
        </p:pic>
        <p:pic>
          <p:nvPicPr>
            <p:cNvPr id="58" name="Picture 57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866254" y="3785790"/>
              <a:ext cx="1797628" cy="23770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025850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04825" y="3210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2</a:t>
            </a:r>
          </a:p>
        </p:txBody>
      </p:sp>
      <p:sp>
        <p:nvSpPr>
          <p:cNvPr id="2" name="Rectangle 1"/>
          <p:cNvSpPr/>
          <p:nvPr/>
        </p:nvSpPr>
        <p:spPr>
          <a:xfrm>
            <a:off x="431673" y="5501270"/>
            <a:ext cx="111061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ig.2)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tio of cell numbers in top layer to total cell number for GFP+ and GFP- DCs in percentage. Top layer is set to z-values above half the distance of given highest and lowest detected GFP+ DC. 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fference of  ratios in GFP+ to GFP- DC from analysis shown in (A) with mean ± SD of (16.9 ± 7.0)%. Each bar represents one acquired dataset, in total 8 independent experiment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xmlns="" id="{41D41C47-5C07-4151-99EC-8F38F77CA11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2889" y="1111023"/>
            <a:ext cx="4602889" cy="3522298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xmlns="" id="{1321262C-0684-41A1-B067-F1647B7D0D6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4963" y="1122246"/>
            <a:ext cx="4588223" cy="351107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8527" y="8038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984748" y="8144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4396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12">
            <a:extLst>
              <a:ext uri="{FF2B5EF4-FFF2-40B4-BE49-F238E27FC236}">
                <a16:creationId xmlns:a16="http://schemas.microsoft.com/office/drawing/2014/main" xmlns="" id="{11B592EA-68B0-4A01-AB8A-DAA87ED13B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4055664"/>
              </p:ext>
            </p:extLst>
          </p:nvPr>
        </p:nvGraphicFramePr>
        <p:xfrm>
          <a:off x="7701598" y="1640588"/>
          <a:ext cx="4059532" cy="146381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0853">
                  <a:extLst>
                    <a:ext uri="{9D8B030D-6E8A-4147-A177-3AD203B41FA5}">
                      <a16:colId xmlns:a16="http://schemas.microsoft.com/office/drawing/2014/main" xmlns="" val="1703675914"/>
                    </a:ext>
                  </a:extLst>
                </a:gridCol>
                <a:gridCol w="1133475">
                  <a:extLst>
                    <a:ext uri="{9D8B030D-6E8A-4147-A177-3AD203B41FA5}">
                      <a16:colId xmlns:a16="http://schemas.microsoft.com/office/drawing/2014/main" xmlns="" val="3209881173"/>
                    </a:ext>
                  </a:extLst>
                </a:gridCol>
                <a:gridCol w="895350">
                  <a:extLst>
                    <a:ext uri="{9D8B030D-6E8A-4147-A177-3AD203B41FA5}">
                      <a16:colId xmlns:a16="http://schemas.microsoft.com/office/drawing/2014/main" xmlns="" val="1066417602"/>
                    </a:ext>
                  </a:extLst>
                </a:gridCol>
                <a:gridCol w="1049854">
                  <a:extLst>
                    <a:ext uri="{9D8B030D-6E8A-4147-A177-3AD203B41FA5}">
                      <a16:colId xmlns:a16="http://schemas.microsoft.com/office/drawing/2014/main" xmlns="" val="3059389505"/>
                    </a:ext>
                  </a:extLst>
                </a:gridCol>
              </a:tblGrid>
              <a:tr h="665369">
                <a:tc>
                  <a:txBody>
                    <a:bodyPr/>
                    <a:lstStyle/>
                    <a:p>
                      <a:pPr algn="ctr"/>
                      <a:endParaRPr lang="de-DE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42448" marR="142448" marT="71223" marB="71223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/min]</a:t>
                      </a:r>
                    </a:p>
                  </a:txBody>
                  <a:tcPr marL="142448" marR="142448" marT="71223" marB="7122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</a:t>
                      </a: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/min]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endParaRPr lang="de-DE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/min]</a:t>
                      </a:r>
                    </a:p>
                  </a:txBody>
                  <a:tcPr marL="142448" marR="142448" marT="71223" marB="71223" anchor="ctr"/>
                </a:tc>
                <a:extLst>
                  <a:ext uri="{0D108BD9-81ED-4DB2-BD59-A6C34878D82A}">
                    <a16:rowId xmlns:a16="http://schemas.microsoft.com/office/drawing/2014/main" xmlns="" val="3009749080"/>
                  </a:ext>
                </a:extLst>
              </a:tr>
              <a:tr h="399221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P-</a:t>
                      </a:r>
                      <a:r>
                        <a:rPr lang="de-DE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s</a:t>
                      </a:r>
                    </a:p>
                  </a:txBody>
                  <a:tcPr marL="142448" marR="142448" marT="71223" marB="71223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 ± 2.4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6</a:t>
                      </a:r>
                    </a:p>
                  </a:txBody>
                  <a:tcPr marL="142448" marR="142448" marT="71223" marB="71223" anchor="ctr"/>
                </a:tc>
                <a:extLst>
                  <a:ext uri="{0D108BD9-81ED-4DB2-BD59-A6C34878D82A}">
                    <a16:rowId xmlns:a16="http://schemas.microsoft.com/office/drawing/2014/main" xmlns="" val="2233346614"/>
                  </a:ext>
                </a:extLst>
              </a:tr>
              <a:tr h="399221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P+</a:t>
                      </a:r>
                      <a:r>
                        <a:rPr lang="de-DE" sz="12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s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7 ± 4.6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</a:t>
                      </a:r>
                    </a:p>
                  </a:txBody>
                  <a:tcPr marL="142448" marR="142448" marT="71223" marB="71223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</a:t>
                      </a:r>
                    </a:p>
                  </a:txBody>
                  <a:tcPr marL="142448" marR="142448" marT="71223" marB="71223" anchor="ctr"/>
                </a:tc>
                <a:extLst>
                  <a:ext uri="{0D108BD9-81ED-4DB2-BD59-A6C34878D82A}">
                    <a16:rowId xmlns:a16="http://schemas.microsoft.com/office/drawing/2014/main" xmlns="" val="124030278"/>
                  </a:ext>
                </a:extLst>
              </a:tr>
            </a:tbl>
          </a:graphicData>
        </a:graphic>
      </p:graphicFrame>
      <p:graphicFrame>
        <p:nvGraphicFramePr>
          <p:cNvPr id="5" name="Tabelle 14">
            <a:extLst>
              <a:ext uri="{FF2B5EF4-FFF2-40B4-BE49-F238E27FC236}">
                <a16:creationId xmlns:a16="http://schemas.microsoft.com/office/drawing/2014/main" xmlns="" id="{69A5D8C3-2460-4D6A-9B98-5DF370AB15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2385629"/>
              </p:ext>
            </p:extLst>
          </p:nvPr>
        </p:nvGraphicFramePr>
        <p:xfrm>
          <a:off x="7701598" y="3461294"/>
          <a:ext cx="4055183" cy="130848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6029">
                  <a:extLst>
                    <a:ext uri="{9D8B030D-6E8A-4147-A177-3AD203B41FA5}">
                      <a16:colId xmlns:a16="http://schemas.microsoft.com/office/drawing/2014/main" xmlns="" val="1703675914"/>
                    </a:ext>
                  </a:extLst>
                </a:gridCol>
                <a:gridCol w="1127261">
                  <a:extLst>
                    <a:ext uri="{9D8B030D-6E8A-4147-A177-3AD203B41FA5}">
                      <a16:colId xmlns:a16="http://schemas.microsoft.com/office/drawing/2014/main" xmlns="" val="3209881173"/>
                    </a:ext>
                  </a:extLst>
                </a:gridCol>
                <a:gridCol w="891540">
                  <a:extLst>
                    <a:ext uri="{9D8B030D-6E8A-4147-A177-3AD203B41FA5}">
                      <a16:colId xmlns:a16="http://schemas.microsoft.com/office/drawing/2014/main" xmlns="" val="1066417602"/>
                    </a:ext>
                  </a:extLst>
                </a:gridCol>
                <a:gridCol w="1050353">
                  <a:extLst>
                    <a:ext uri="{9D8B030D-6E8A-4147-A177-3AD203B41FA5}">
                      <a16:colId xmlns:a16="http://schemas.microsoft.com/office/drawing/2014/main" xmlns="" val="3059389505"/>
                    </a:ext>
                  </a:extLst>
                </a:gridCol>
              </a:tblGrid>
              <a:tr h="577425">
                <a:tc>
                  <a:txBody>
                    <a:bodyPr/>
                    <a:lstStyle/>
                    <a:p>
                      <a:pPr algn="ctr"/>
                      <a:endParaRPr lang="de-DE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3322" marR="123322" marT="61662" marB="61662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</a:t>
                      </a: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]</a:t>
                      </a:r>
                    </a:p>
                  </a:txBody>
                  <a:tcPr marL="123322" marR="123322" marT="61662" marB="61662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n</a:t>
                      </a: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]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x</a:t>
                      </a:r>
                      <a:endParaRPr lang="de-DE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µm]</a:t>
                      </a:r>
                    </a:p>
                  </a:txBody>
                  <a:tcPr marL="123322" marR="123322" marT="61662" marB="61662" anchor="ctr"/>
                </a:tc>
                <a:extLst>
                  <a:ext uri="{0D108BD9-81ED-4DB2-BD59-A6C34878D82A}">
                    <a16:rowId xmlns:a16="http://schemas.microsoft.com/office/drawing/2014/main" xmlns="" val="3009749080"/>
                  </a:ext>
                </a:extLst>
              </a:tr>
              <a:tr h="355326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P- DCs</a:t>
                      </a:r>
                    </a:p>
                  </a:txBody>
                  <a:tcPr marL="123322" marR="123322" marT="61662" marB="61662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4 ± 42.0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4.7</a:t>
                      </a:r>
                    </a:p>
                  </a:txBody>
                  <a:tcPr marL="123322" marR="123322" marT="61662" marB="61662" anchor="ctr"/>
                </a:tc>
                <a:extLst>
                  <a:ext uri="{0D108BD9-81ED-4DB2-BD59-A6C34878D82A}">
                    <a16:rowId xmlns:a16="http://schemas.microsoft.com/office/drawing/2014/main" xmlns="" val="2233346614"/>
                  </a:ext>
                </a:extLst>
              </a:tr>
              <a:tr h="375731"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FP+ DCs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5 ± 58.9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</a:t>
                      </a:r>
                    </a:p>
                  </a:txBody>
                  <a:tcPr marL="123322" marR="123322" marT="61662" marB="6166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9.9</a:t>
                      </a:r>
                    </a:p>
                  </a:txBody>
                  <a:tcPr marL="123322" marR="123322" marT="61662" marB="61662" anchor="ctr"/>
                </a:tc>
                <a:extLst>
                  <a:ext uri="{0D108BD9-81ED-4DB2-BD59-A6C34878D82A}">
                    <a16:rowId xmlns:a16="http://schemas.microsoft.com/office/drawing/2014/main" xmlns="" val="124030278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04825" y="3210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3</a:t>
            </a:r>
          </a:p>
        </p:txBody>
      </p:sp>
      <p:sp>
        <p:nvSpPr>
          <p:cNvPr id="2" name="Rectangle 1"/>
          <p:cNvSpPr/>
          <p:nvPr/>
        </p:nvSpPr>
        <p:spPr>
          <a:xfrm>
            <a:off x="431673" y="5501270"/>
            <a:ext cx="111061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Fig.3) A)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D time lapse tracks of GFP- (left panel, n=1722) and GFP+ DCs (n=76) (right panel) through the 3D model with track lengths being time color coded. Scale bars, 200 µm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Velocity and track length were quantified (top and bottom tables respectively). The data shown is representative of at least three independent experiment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825" y="1439735"/>
            <a:ext cx="7048709" cy="221788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68527" y="8038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553534" y="8038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04725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779977" y="4347256"/>
            <a:ext cx="1821802" cy="292388"/>
            <a:chOff x="1800225" y="4628048"/>
            <a:chExt cx="1821802" cy="292388"/>
          </a:xfrm>
        </p:grpSpPr>
        <p:sp>
          <p:nvSpPr>
            <p:cNvPr id="2" name="TextBox 1"/>
            <p:cNvSpPr txBox="1"/>
            <p:nvPr/>
          </p:nvSpPr>
          <p:spPr>
            <a:xfrm>
              <a:off x="1800225" y="4643437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Y27632</a:t>
              </a:r>
              <a:endParaRPr lang="en-US" sz="1200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769490" y="4628048"/>
              <a:ext cx="256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365028" y="4635743"/>
              <a:ext cx="256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4519193" y="4355460"/>
            <a:ext cx="1810639" cy="292388"/>
            <a:chOff x="4514430" y="4627594"/>
            <a:chExt cx="1810639" cy="292388"/>
          </a:xfrm>
        </p:grpSpPr>
        <p:sp>
          <p:nvSpPr>
            <p:cNvPr id="12" name="TextBox 11"/>
            <p:cNvSpPr txBox="1"/>
            <p:nvPr/>
          </p:nvSpPr>
          <p:spPr>
            <a:xfrm>
              <a:off x="5471690" y="4627595"/>
              <a:ext cx="256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068070" y="4627594"/>
              <a:ext cx="2569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514430" y="4642983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Y27632</a:t>
              </a:r>
              <a:endParaRPr lang="en-US" sz="1200" dirty="0"/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2877741" y="1522885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562601" y="1522885"/>
            <a:ext cx="5918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FP+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19125" y="5403739"/>
            <a:ext cx="102412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ig. 4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cumulated distance of single cell tracks of GFP- (left) and GFP+ (right) DCs pre-exposed to Y27632 treated (30 µM) or not in collagen matrix (2 mg/mL). Graphs show mean ± SEM of three independent experiment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9977" y="2140866"/>
            <a:ext cx="2096471" cy="292189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9193" y="2120836"/>
            <a:ext cx="2096471" cy="222642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4825" y="3210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8912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24712" y="832104"/>
            <a:ext cx="1821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1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– Video S1</a:t>
            </a:r>
            <a:endParaRPr lang="en-US" dirty="0"/>
          </a:p>
        </p:txBody>
      </p:sp>
      <p:pic>
        <p:nvPicPr>
          <p:cNvPr id="5" name="14 positions.czi - 14 positions #15_scalebar20um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24712" y="1708150"/>
            <a:ext cx="4178808" cy="334644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914401" y="5542258"/>
            <a:ext cx="10076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Video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FP+ DC rather than GFP- ones acquired a polarized migratory phenotype in collagen matrices required for fast migration. Scale bar: 20 µm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85809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V-DC_edited_scalebar10um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908194" y="1640719"/>
            <a:ext cx="4769694" cy="259905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44186" y="533959"/>
            <a:ext cx="1821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2 –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Video S2</a:t>
            </a:r>
            <a:endParaRPr lang="en-US" dirty="0"/>
          </a:p>
        </p:txBody>
      </p:sp>
      <p:pic>
        <p:nvPicPr>
          <p:cNvPr id="6" name="Uninfected-filopodia - 14 positions #11_scalebar20um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7770240" y="1640719"/>
            <a:ext cx="3220848" cy="395844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470676" y="5944362"/>
            <a:ext cx="70363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Video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ilopodi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tivity in GFP- DCs in collagen matrix. Scale bars: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0 µm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20 µm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44186" y="11181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455730" y="111811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71411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899938" y="5707641"/>
            <a:ext cx="102412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ig. 5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locity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gration distances of single cell tracks of GFP- DCs pre-exposed to SKI-II treated (10 µM) or not (Ctrl) in collagen matrix (2 mg/mL). Graphs show mean ± SEM of three independent experiments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2257" y="5496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9938" y="2069306"/>
            <a:ext cx="2680433" cy="267383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63336" y="2127294"/>
            <a:ext cx="2595050" cy="266927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1351" y="2157571"/>
            <a:ext cx="2497468" cy="2585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93835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6595679"/>
              </p:ext>
            </p:extLst>
          </p:nvPr>
        </p:nvGraphicFramePr>
        <p:xfrm>
          <a:off x="1307806" y="1894862"/>
          <a:ext cx="4199859" cy="2732568"/>
        </p:xfrm>
        <a:graphic>
          <a:graphicData uri="http://schemas.openxmlformats.org/drawingml/2006/table">
            <a:tbl>
              <a:tblPr>
                <a:tableStyleId>{D7AC3CCA-C797-4891-BE02-D94E43425B78}</a:tableStyleId>
              </a:tblPr>
              <a:tblGrid>
                <a:gridCol w="7512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512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4753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74992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623372"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C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Cs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Mock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-infected DCs</a:t>
                      </a:r>
                    </a:p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ction rate &lt; 50%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27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71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27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6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4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27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4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8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527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1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8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4833840"/>
              </p:ext>
            </p:extLst>
          </p:nvPr>
        </p:nvGraphicFramePr>
        <p:xfrm>
          <a:off x="6858002" y="1894862"/>
          <a:ext cx="4189227" cy="2732568"/>
        </p:xfrm>
        <a:graphic>
          <a:graphicData uri="http://schemas.openxmlformats.org/drawingml/2006/table">
            <a:tbl>
              <a:tblPr>
                <a:tableStyleId>{D7AC3CCA-C797-4891-BE02-D94E43425B78}</a:tableStyleId>
              </a:tblPr>
              <a:tblGrid>
                <a:gridCol w="76323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6323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3309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72965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739498"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C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Cs</a:t>
                      </a:r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 Mock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V-infected DCs</a:t>
                      </a:r>
                    </a:p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fection rate &gt;50%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986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986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6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986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7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986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986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6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5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627321" y="5603359"/>
            <a:ext cx="108345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6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w values of intracellular S1P measurements in at least three independent experiments. Each row shows values for one independent donor in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o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sample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V infected DCs with infection rates lower than 50%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V infected DCs with infection rates higher than 50% are shown.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32257" y="549601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. 6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93296" y="151485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556360" y="151485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139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727</Words>
  <Application>Microsoft Office PowerPoint</Application>
  <PresentationFormat>Widescreen</PresentationFormat>
  <Paragraphs>149</Paragraphs>
  <Slides>9</Slides>
  <Notes>1</Notes>
  <HiddenSlides>0</HiddenSlides>
  <MMClips>3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MS PGothic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ghayegh derakhshani</dc:creator>
  <cp:lastModifiedBy>shaghayegh derakhshani</cp:lastModifiedBy>
  <cp:revision>70</cp:revision>
  <dcterms:created xsi:type="dcterms:W3CDTF">2019-01-10T14:30:39Z</dcterms:created>
  <dcterms:modified xsi:type="dcterms:W3CDTF">2019-05-26T17:43:38Z</dcterms:modified>
  <cp:contentStatus/>
</cp:coreProperties>
</file>